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  <p:sldId id="256" r:id="rId3"/>
    <p:sldId id="267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8" d="100"/>
          <a:sy n="78" d="100"/>
        </p:scale>
        <p:origin x="1522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hivani\calcium-manuscript\calcium-manuscript\final-stage\DCL_SE_HYL%20inhibitor%20and%20ionophor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Expression of miRNA processing enzymes under Ca2+ scarcity and excess</a:t>
            </a:r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9.7047025371828494E-2"/>
          <c:y val="6.0185185185185203E-2"/>
          <c:w val="0.85367169728783898"/>
          <c:h val="0.822469378827647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F$5</c:f>
              <c:strCache>
                <c:ptCount val="1"/>
                <c:pt idx="0">
                  <c:v>DCL1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  <a:effectLst/>
          </c:spPr>
          <c:invertIfNegative val="0"/>
          <c:cat>
            <c:strRef>
              <c:f>Sheet1!$E$6:$E$8</c:f>
              <c:strCache>
                <c:ptCount val="3"/>
                <c:pt idx="0">
                  <c:v>control</c:v>
                </c:pt>
                <c:pt idx="1">
                  <c:v>Inh</c:v>
                </c:pt>
                <c:pt idx="2">
                  <c:v>Ionophore</c:v>
                </c:pt>
              </c:strCache>
            </c:strRef>
          </c:cat>
          <c:val>
            <c:numRef>
              <c:f>Sheet1!$F$6:$F$8</c:f>
              <c:numCache>
                <c:formatCode>General</c:formatCode>
                <c:ptCount val="3"/>
                <c:pt idx="0">
                  <c:v>1</c:v>
                </c:pt>
                <c:pt idx="1">
                  <c:v>0.75570144099334902</c:v>
                </c:pt>
                <c:pt idx="2">
                  <c:v>1.9328643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B6-46D4-8F90-BC9B577F3CDE}"/>
            </c:ext>
          </c:extLst>
        </c:ser>
        <c:ser>
          <c:idx val="1"/>
          <c:order val="1"/>
          <c:tx>
            <c:strRef>
              <c:f>Sheet1!$G$5</c:f>
              <c:strCache>
                <c:ptCount val="1"/>
                <c:pt idx="0">
                  <c:v>HYL1</c:v>
                </c:pt>
              </c:strCache>
            </c:strRef>
          </c:tx>
          <c:spPr>
            <a:pattFill prst="pct5">
              <a:fgClr>
                <a:schemeClr val="tx1">
                  <a:lumMod val="50000"/>
                  <a:lumOff val="50000"/>
                </a:schemeClr>
              </a:fgClr>
              <a:bgClr>
                <a:schemeClr val="bg1"/>
              </a:bgClr>
            </a:patt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c:spPr>
          <c:invertIfNegative val="0"/>
          <c:cat>
            <c:strRef>
              <c:f>Sheet1!$E$6:$E$8</c:f>
              <c:strCache>
                <c:ptCount val="3"/>
                <c:pt idx="0">
                  <c:v>control</c:v>
                </c:pt>
                <c:pt idx="1">
                  <c:v>Inh</c:v>
                </c:pt>
                <c:pt idx="2">
                  <c:v>Ionophore</c:v>
                </c:pt>
              </c:strCache>
            </c:strRef>
          </c:cat>
          <c:val>
            <c:numRef>
              <c:f>Sheet1!$G$6:$G$8</c:f>
              <c:numCache>
                <c:formatCode>General</c:formatCode>
                <c:ptCount val="3"/>
                <c:pt idx="0">
                  <c:v>1</c:v>
                </c:pt>
                <c:pt idx="1">
                  <c:v>0.83225304053369598</c:v>
                </c:pt>
                <c:pt idx="2">
                  <c:v>1.11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7B6-46D4-8F90-BC9B577F3CDE}"/>
            </c:ext>
          </c:extLst>
        </c:ser>
        <c:ser>
          <c:idx val="2"/>
          <c:order val="2"/>
          <c:tx>
            <c:strRef>
              <c:f>Sheet1!$H$5</c:f>
              <c:strCache>
                <c:ptCount val="1"/>
                <c:pt idx="0">
                  <c:v>SE</c:v>
                </c:pt>
              </c:strCache>
            </c:strRef>
          </c:tx>
          <c:spPr>
            <a:pattFill prst="smCheck">
              <a:fgClr>
                <a:schemeClr val="tx1">
                  <a:lumMod val="65000"/>
                  <a:lumOff val="35000"/>
                </a:schemeClr>
              </a:fgClr>
              <a:bgClr>
                <a:schemeClr val="bg1"/>
              </a:bgClr>
            </a:patt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c:spPr>
          <c:invertIfNegative val="0"/>
          <c:cat>
            <c:strRef>
              <c:f>Sheet1!$E$6:$E$8</c:f>
              <c:strCache>
                <c:ptCount val="3"/>
                <c:pt idx="0">
                  <c:v>control</c:v>
                </c:pt>
                <c:pt idx="1">
                  <c:v>Inh</c:v>
                </c:pt>
                <c:pt idx="2">
                  <c:v>Ionophore</c:v>
                </c:pt>
              </c:strCache>
            </c:strRef>
          </c:cat>
          <c:val>
            <c:numRef>
              <c:f>Sheet1!$H$6:$H$8</c:f>
              <c:numCache>
                <c:formatCode>General</c:formatCode>
                <c:ptCount val="3"/>
                <c:pt idx="0">
                  <c:v>1</c:v>
                </c:pt>
                <c:pt idx="1">
                  <c:v>0.192062283737025</c:v>
                </c:pt>
                <c:pt idx="2">
                  <c:v>1.3333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7B6-46D4-8F90-BC9B577F3C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705213688"/>
        <c:axId val="1705241192"/>
      </c:barChart>
      <c:catAx>
        <c:axId val="17052136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705241192"/>
        <c:crosses val="autoZero"/>
        <c:auto val="1"/>
        <c:lblAlgn val="ctr"/>
        <c:lblOffset val="100"/>
        <c:noMultiLvlLbl val="0"/>
      </c:catAx>
      <c:valAx>
        <c:axId val="17052411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expression level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7052136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9154377150577349"/>
          <c:y val="0.115164771070283"/>
          <c:w val="0.15499313926241792"/>
          <c:h val="0.233966535433071"/>
        </c:manualLayout>
      </c:layout>
      <c:overlay val="0"/>
    </c:legend>
    <c:plotVisOnly val="1"/>
    <c:dispBlanksAs val="gap"/>
    <c:showDLblsOverMax val="0"/>
  </c:chart>
  <c:spPr>
    <a:ln>
      <a:solidFill>
        <a:schemeClr val="bg1">
          <a:lumMod val="65000"/>
        </a:schemeClr>
      </a:solidFill>
    </a:ln>
  </c:spPr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13126-6800-FA40-9A4A-899C6C0BEB7A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501B2-F98C-EC4F-A5C3-28333E72F6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251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13126-6800-FA40-9A4A-899C6C0BEB7A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501B2-F98C-EC4F-A5C3-28333E72F6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060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13126-6800-FA40-9A4A-899C6C0BEB7A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501B2-F98C-EC4F-A5C3-28333E72F6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18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13126-6800-FA40-9A4A-899C6C0BEB7A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501B2-F98C-EC4F-A5C3-28333E72F6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504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13126-6800-FA40-9A4A-899C6C0BEB7A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501B2-F98C-EC4F-A5C3-28333E72F6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378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13126-6800-FA40-9A4A-899C6C0BEB7A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501B2-F98C-EC4F-A5C3-28333E72F6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178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13126-6800-FA40-9A4A-899C6C0BEB7A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501B2-F98C-EC4F-A5C3-28333E72F6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309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13126-6800-FA40-9A4A-899C6C0BEB7A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501B2-F98C-EC4F-A5C3-28333E72F6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018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13126-6800-FA40-9A4A-899C6C0BEB7A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501B2-F98C-EC4F-A5C3-28333E72F6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767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13126-6800-FA40-9A4A-899C6C0BEB7A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501B2-F98C-EC4F-A5C3-28333E72F6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348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13126-6800-FA40-9A4A-899C6C0BEB7A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501B2-F98C-EC4F-A5C3-28333E72F6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1571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613126-6800-FA40-9A4A-899C6C0BEB7A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9501B2-F98C-EC4F-A5C3-28333E72F6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803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2F818938-00AE-40DE-B47F-7C42FAAA5EDC}"/>
              </a:ext>
            </a:extLst>
          </p:cNvPr>
          <p:cNvCxnSpPr/>
          <p:nvPr/>
        </p:nvCxnSpPr>
        <p:spPr>
          <a:xfrm>
            <a:off x="252249" y="2081048"/>
            <a:ext cx="6552000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A9A2565D-CE7E-46D9-AF92-F3A36E47665C}"/>
              </a:ext>
            </a:extLst>
          </p:cNvPr>
          <p:cNvSpPr/>
          <p:nvPr/>
        </p:nvSpPr>
        <p:spPr>
          <a:xfrm>
            <a:off x="6804249" y="1954924"/>
            <a:ext cx="2003420" cy="304773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A88974D7-6851-41A9-A015-42029C8C451C}"/>
              </a:ext>
            </a:extLst>
          </p:cNvPr>
          <p:cNvCxnSpPr/>
          <p:nvPr/>
        </p:nvCxnSpPr>
        <p:spPr>
          <a:xfrm>
            <a:off x="252249" y="3095296"/>
            <a:ext cx="6552000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40F54692-38EA-4311-815F-AC667C796C0B}"/>
              </a:ext>
            </a:extLst>
          </p:cNvPr>
          <p:cNvSpPr/>
          <p:nvPr/>
        </p:nvSpPr>
        <p:spPr>
          <a:xfrm>
            <a:off x="6804249" y="2969172"/>
            <a:ext cx="2003420" cy="304773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A8A9F8C-2666-48FC-A113-D528EAA37ACD}"/>
              </a:ext>
            </a:extLst>
          </p:cNvPr>
          <p:cNvSpPr txBox="1"/>
          <p:nvPr/>
        </p:nvSpPr>
        <p:spPr>
          <a:xfrm>
            <a:off x="7216551" y="1982698"/>
            <a:ext cx="15911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Pre-miR156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D2CAED8-4250-476E-BF15-D044391FE243}"/>
              </a:ext>
            </a:extLst>
          </p:cNvPr>
          <p:cNvSpPr txBox="1"/>
          <p:nvPr/>
        </p:nvSpPr>
        <p:spPr>
          <a:xfrm>
            <a:off x="7300633" y="2969172"/>
            <a:ext cx="15911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latin typeface="Arial" panose="020B0604020202020204" pitchFamily="34" charset="0"/>
                <a:cs typeface="Arial" panose="020B0604020202020204" pitchFamily="34" charset="0"/>
              </a:rPr>
              <a:t>Pre-miR167h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B781350D-910D-4AB8-B8FF-2B7159CD03A6}"/>
              </a:ext>
            </a:extLst>
          </p:cNvPr>
          <p:cNvCxnSpPr/>
          <p:nvPr/>
        </p:nvCxnSpPr>
        <p:spPr>
          <a:xfrm>
            <a:off x="5181597" y="1928634"/>
            <a:ext cx="0" cy="28378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C344AA2A-A159-480E-A69B-51059B575CF8}"/>
              </a:ext>
            </a:extLst>
          </p:cNvPr>
          <p:cNvCxnSpPr/>
          <p:nvPr/>
        </p:nvCxnSpPr>
        <p:spPr>
          <a:xfrm>
            <a:off x="3577360" y="1930148"/>
            <a:ext cx="0" cy="28378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4F5B471C-85B8-42FC-ABB4-5F4B4D57DC96}"/>
              </a:ext>
            </a:extLst>
          </p:cNvPr>
          <p:cNvCxnSpPr/>
          <p:nvPr/>
        </p:nvCxnSpPr>
        <p:spPr>
          <a:xfrm>
            <a:off x="1945437" y="1939158"/>
            <a:ext cx="0" cy="28378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DD58BDB-A71D-439D-B390-F653129BAD10}"/>
              </a:ext>
            </a:extLst>
          </p:cNvPr>
          <p:cNvCxnSpPr>
            <a:cxnSpLocks/>
          </p:cNvCxnSpPr>
          <p:nvPr/>
        </p:nvCxnSpPr>
        <p:spPr>
          <a:xfrm flipH="1">
            <a:off x="1872324" y="2343809"/>
            <a:ext cx="432000" cy="0"/>
          </a:xfrm>
          <a:prstGeom prst="line">
            <a:avLst/>
          </a:prstGeom>
          <a:ln w="38100">
            <a:solidFill>
              <a:schemeClr val="accent6">
                <a:lumMod val="7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FD1A3AC-66B4-4F61-A309-5CD105C9FB1D}"/>
              </a:ext>
            </a:extLst>
          </p:cNvPr>
          <p:cNvCxnSpPr/>
          <p:nvPr/>
        </p:nvCxnSpPr>
        <p:spPr>
          <a:xfrm>
            <a:off x="252249" y="1940658"/>
            <a:ext cx="0" cy="28378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602A497B-FB62-41D9-898E-48E662D602F2}"/>
              </a:ext>
            </a:extLst>
          </p:cNvPr>
          <p:cNvSpPr txBox="1"/>
          <p:nvPr/>
        </p:nvSpPr>
        <p:spPr>
          <a:xfrm>
            <a:off x="5013434" y="1634569"/>
            <a:ext cx="5675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>
                <a:latin typeface="Arial" panose="020B0604020202020204" pitchFamily="34" charset="0"/>
                <a:cs typeface="Arial" panose="020B0604020202020204" pitchFamily="34" charset="0"/>
              </a:rPr>
              <a:t>-50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C974001-A2FF-4277-8112-1CFF2113AB92}"/>
              </a:ext>
            </a:extLst>
          </p:cNvPr>
          <p:cNvSpPr txBox="1"/>
          <p:nvPr/>
        </p:nvSpPr>
        <p:spPr>
          <a:xfrm>
            <a:off x="3355939" y="1639953"/>
            <a:ext cx="5675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>
                <a:latin typeface="Arial" panose="020B0604020202020204" pitchFamily="34" charset="0"/>
                <a:cs typeface="Arial" panose="020B0604020202020204" pitchFamily="34" charset="0"/>
              </a:rPr>
              <a:t>-100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3A500CD-E9B6-4209-8FE4-2A2A69208630}"/>
              </a:ext>
            </a:extLst>
          </p:cNvPr>
          <p:cNvSpPr txBox="1"/>
          <p:nvPr/>
        </p:nvSpPr>
        <p:spPr>
          <a:xfrm>
            <a:off x="1756634" y="1634569"/>
            <a:ext cx="5675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>
                <a:latin typeface="Arial" panose="020B0604020202020204" pitchFamily="34" charset="0"/>
                <a:cs typeface="Arial" panose="020B0604020202020204" pitchFamily="34" charset="0"/>
              </a:rPr>
              <a:t>-150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036467-4423-435D-A4BF-A003CBC96D06}"/>
              </a:ext>
            </a:extLst>
          </p:cNvPr>
          <p:cNvSpPr txBox="1"/>
          <p:nvPr/>
        </p:nvSpPr>
        <p:spPr>
          <a:xfrm>
            <a:off x="8075" y="1639953"/>
            <a:ext cx="5675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>
                <a:latin typeface="Arial" panose="020B0604020202020204" pitchFamily="34" charset="0"/>
                <a:cs typeface="Arial" panose="020B0604020202020204" pitchFamily="34" charset="0"/>
              </a:rPr>
              <a:t>-2000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623BE5C2-5213-40B1-9AAD-9560D8A88996}"/>
              </a:ext>
            </a:extLst>
          </p:cNvPr>
          <p:cNvSpPr/>
          <p:nvPr/>
        </p:nvSpPr>
        <p:spPr>
          <a:xfrm>
            <a:off x="2040414" y="1919638"/>
            <a:ext cx="72159" cy="304773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6292661-298A-4A31-A68F-C6237479DD54}"/>
              </a:ext>
            </a:extLst>
          </p:cNvPr>
          <p:cNvSpPr/>
          <p:nvPr/>
        </p:nvSpPr>
        <p:spPr>
          <a:xfrm>
            <a:off x="664552" y="1914369"/>
            <a:ext cx="72159" cy="304773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5291D9EE-CE32-4307-A3DF-435AA8B13CC1}"/>
              </a:ext>
            </a:extLst>
          </p:cNvPr>
          <p:cNvSpPr/>
          <p:nvPr/>
        </p:nvSpPr>
        <p:spPr>
          <a:xfrm>
            <a:off x="510616" y="1917966"/>
            <a:ext cx="72159" cy="304773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ED945521-B268-48CC-8EEC-BBB2DD8D2FD9}"/>
              </a:ext>
            </a:extLst>
          </p:cNvPr>
          <p:cNvSpPr/>
          <p:nvPr/>
        </p:nvSpPr>
        <p:spPr>
          <a:xfrm>
            <a:off x="2357918" y="2926009"/>
            <a:ext cx="72159" cy="304773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2C28D6B2-018E-4B7B-A275-A73ADFEF96BB}"/>
              </a:ext>
            </a:extLst>
          </p:cNvPr>
          <p:cNvSpPr/>
          <p:nvPr/>
        </p:nvSpPr>
        <p:spPr>
          <a:xfrm>
            <a:off x="5508835" y="3824278"/>
            <a:ext cx="72159" cy="304773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7482F96-0D94-4FD5-B513-3A24C18E8E71}"/>
              </a:ext>
            </a:extLst>
          </p:cNvPr>
          <p:cNvSpPr txBox="1"/>
          <p:nvPr/>
        </p:nvSpPr>
        <p:spPr>
          <a:xfrm>
            <a:off x="5580994" y="3806433"/>
            <a:ext cx="20034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AMTA binding site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A888A27F-2D87-4251-BF67-13748FE6B734}"/>
              </a:ext>
            </a:extLst>
          </p:cNvPr>
          <p:cNvCxnSpPr>
            <a:cxnSpLocks/>
          </p:cNvCxnSpPr>
          <p:nvPr/>
        </p:nvCxnSpPr>
        <p:spPr>
          <a:xfrm flipH="1">
            <a:off x="2040414" y="3376450"/>
            <a:ext cx="756000" cy="0"/>
          </a:xfrm>
          <a:prstGeom prst="line">
            <a:avLst/>
          </a:prstGeom>
          <a:ln w="38100">
            <a:solidFill>
              <a:schemeClr val="accent6">
                <a:lumMod val="7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65005DCC-FFEB-426B-846E-E24F3BCBF634}"/>
              </a:ext>
            </a:extLst>
          </p:cNvPr>
          <p:cNvCxnSpPr/>
          <p:nvPr/>
        </p:nvCxnSpPr>
        <p:spPr>
          <a:xfrm>
            <a:off x="6804249" y="1072055"/>
            <a:ext cx="0" cy="208800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Isosceles Triangle 24">
            <a:extLst>
              <a:ext uri="{FF2B5EF4-FFF2-40B4-BE49-F238E27FC236}">
                <a16:creationId xmlns:a16="http://schemas.microsoft.com/office/drawing/2014/main" id="{C924707C-8722-47BC-B0A5-F5FDBD03DF6D}"/>
              </a:ext>
            </a:extLst>
          </p:cNvPr>
          <p:cNvSpPr/>
          <p:nvPr/>
        </p:nvSpPr>
        <p:spPr>
          <a:xfrm rot="16200000">
            <a:off x="6369838" y="1039337"/>
            <a:ext cx="396000" cy="432000"/>
          </a:xfrm>
          <a:prstGeom prst="triangl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4A74129-A0DE-478B-9F6E-493481262DC2}"/>
              </a:ext>
            </a:extLst>
          </p:cNvPr>
          <p:cNvSpPr txBox="1"/>
          <p:nvPr/>
        </p:nvSpPr>
        <p:spPr>
          <a:xfrm>
            <a:off x="6804249" y="1691812"/>
            <a:ext cx="212309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hr1: 22524246 - 22524147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0E58BBC-9345-4FFC-AFFE-24C6B90D8EAA}"/>
              </a:ext>
            </a:extLst>
          </p:cNvPr>
          <p:cNvSpPr txBox="1"/>
          <p:nvPr/>
        </p:nvSpPr>
        <p:spPr>
          <a:xfrm>
            <a:off x="6768661" y="2739425"/>
            <a:ext cx="212309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hr12: 25480618-25480737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8888EC97-D3B5-452C-B110-9158F1DDF8F5}"/>
              </a:ext>
            </a:extLst>
          </p:cNvPr>
          <p:cNvCxnSpPr>
            <a:cxnSpLocks/>
          </p:cNvCxnSpPr>
          <p:nvPr/>
        </p:nvCxnSpPr>
        <p:spPr>
          <a:xfrm flipH="1">
            <a:off x="5202994" y="4306616"/>
            <a:ext cx="341920" cy="0"/>
          </a:xfrm>
          <a:prstGeom prst="line">
            <a:avLst/>
          </a:prstGeom>
          <a:ln w="38100">
            <a:solidFill>
              <a:schemeClr val="accent6">
                <a:lumMod val="7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3E1ED1EA-4D09-462F-B45D-831B5C617E3C}"/>
              </a:ext>
            </a:extLst>
          </p:cNvPr>
          <p:cNvSpPr txBox="1"/>
          <p:nvPr/>
        </p:nvSpPr>
        <p:spPr>
          <a:xfrm>
            <a:off x="5580994" y="4169048"/>
            <a:ext cx="20034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Cloned fragmen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E42F4E0-4D5F-4EA1-8BF2-3B95DF6BCA4F}"/>
              </a:ext>
            </a:extLst>
          </p:cNvPr>
          <p:cNvSpPr txBox="1"/>
          <p:nvPr/>
        </p:nvSpPr>
        <p:spPr>
          <a:xfrm>
            <a:off x="664552" y="5055476"/>
            <a:ext cx="7902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800" b="1" dirty="0">
                <a:effectLst/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1: </a:t>
            </a:r>
            <a:r>
              <a:rPr lang="en-IN" sz="1800" dirty="0">
                <a:effectLst/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e diagram depicting the promoter sites cloned for Y-1H experiment. 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911268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019034" y="1650045"/>
            <a:ext cx="3837254" cy="2551115"/>
          </a:xfrm>
          <a:prstGeom prst="rect">
            <a:avLst/>
          </a:prstGeom>
          <a:noFill/>
        </p:spPr>
      </p:pic>
      <p:sp>
        <p:nvSpPr>
          <p:cNvPr id="7" name="Rectangle 6"/>
          <p:cNvSpPr/>
          <p:nvPr/>
        </p:nvSpPr>
        <p:spPr>
          <a:xfrm>
            <a:off x="2144885" y="4201160"/>
            <a:ext cx="4572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IN" dirty="0"/>
              <a:t>Fig S2: </a:t>
            </a:r>
            <a:r>
              <a:rPr lang="en-IN" sz="1800" b="1" dirty="0">
                <a:effectLst/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IN" sz="1800" dirty="0">
                <a:effectLst/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ression of OsCPK6 in response to various treatments under study. OsCPK6 has been considered as a marker for efficiency check of calcium scarcity and excess environments created by the use of calcium channel inhibitors and ionophore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366073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/>
        </p:nvGraphicFramePr>
        <p:xfrm>
          <a:off x="2795588" y="2535238"/>
          <a:ext cx="3552825" cy="21129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E36ACF9B-2CE6-416B-99F2-67E1418CDA80}"/>
              </a:ext>
            </a:extLst>
          </p:cNvPr>
          <p:cNvSpPr/>
          <p:nvPr/>
        </p:nvSpPr>
        <p:spPr>
          <a:xfrm>
            <a:off x="2060910" y="4796411"/>
            <a:ext cx="4572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IN" dirty="0"/>
              <a:t>Fig S3: </a:t>
            </a:r>
            <a:r>
              <a:rPr lang="en-IN" sz="1800" dirty="0">
                <a:effectLst/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ression profile of the three main miRNA processing enzymes namely </a:t>
            </a:r>
            <a:r>
              <a:rPr lang="en-IN" sz="1800" i="1" dirty="0">
                <a:effectLst/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CL1, HYL1 </a:t>
            </a:r>
            <a:r>
              <a:rPr lang="en-IN" sz="1800" dirty="0">
                <a:effectLst/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IN" sz="1800" i="1" dirty="0">
                <a:effectLst/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ERRATE</a:t>
            </a:r>
            <a:r>
              <a:rPr lang="en-IN" sz="1800" dirty="0">
                <a:effectLst/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under Ca</a:t>
            </a:r>
            <a:r>
              <a:rPr lang="en-IN" sz="1800" baseline="30000" dirty="0">
                <a:effectLst/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IN" sz="1800" dirty="0">
                <a:effectLst/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carcity generated by use of channel inhibitors or excess generated by treatment with calcium ionophore.</a:t>
            </a:r>
            <a:endParaRPr lang="en-IN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025996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4900" y="1693467"/>
            <a:ext cx="4069564" cy="245530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144885" y="4201160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IN" dirty="0"/>
              <a:t>Fig S4: Expression of </a:t>
            </a:r>
            <a:r>
              <a:rPr lang="en-IN" dirty="0" err="1"/>
              <a:t>At</a:t>
            </a:r>
            <a:r>
              <a:rPr lang="en-IN" i="1" dirty="0" err="1"/>
              <a:t>CAMTA</a:t>
            </a:r>
            <a:r>
              <a:rPr lang="en-IN" dirty="0"/>
              <a:t> genes in their respective mutant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33773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61</TotalTime>
  <Words>142</Words>
  <Application>Microsoft Office PowerPoint</Application>
  <PresentationFormat>On-screen Show (4:3)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PMB</dc:creator>
  <cp:lastModifiedBy>Shivani Kansal</cp:lastModifiedBy>
  <cp:revision>13</cp:revision>
  <dcterms:created xsi:type="dcterms:W3CDTF">2019-04-10T04:39:53Z</dcterms:created>
  <dcterms:modified xsi:type="dcterms:W3CDTF">2021-08-24T11:06:12Z</dcterms:modified>
</cp:coreProperties>
</file>